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1" r:id="rId6"/>
    <p:sldId id="262" r:id="rId7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21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8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DCD5E8E-B5EC-1CFD-0140-88499570FF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3784DB32-8DBF-0D0C-0D6B-6D1E077E6A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E176350-734E-CF74-5A44-90C32DF3D8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E10A-7B40-430A-83B8-ADE1586ECA43}" type="datetimeFigureOut">
              <a:rPr lang="es-ES" smtClean="0"/>
              <a:t>22/09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230E653-0E9E-864C-C484-5E6CC74C2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10B6333-F293-76E7-B2D1-265C3BBBA1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4E783-9315-47DE-B1E4-5BED25F2D5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33880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F88E013-FC9F-4078-E8AC-654640B18E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D8326EEC-28D5-84E1-C1B4-CC6D41B989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EE21961-1C66-8222-51A2-457E01594E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E10A-7B40-430A-83B8-ADE1586ECA43}" type="datetimeFigureOut">
              <a:rPr lang="es-ES" smtClean="0"/>
              <a:t>22/09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D8B3EE1-C907-35E3-A39C-CA3AD09611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73AF5DE-8625-B0BD-0F61-0346AADCC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4E783-9315-47DE-B1E4-5BED25F2D5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0230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26AAE9C-AAF8-99D9-C046-B02E319B29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8FBAB5C-0931-25CB-C110-E5373EDF8A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0C0E43E-8DD0-6E02-2121-D093B5979A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E10A-7B40-430A-83B8-ADE1586ECA43}" type="datetimeFigureOut">
              <a:rPr lang="es-ES" smtClean="0"/>
              <a:t>22/09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2844119-9DA8-AB22-C61B-D70419340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E1D2D0B-70AB-9B4E-1F8F-369F2545A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4E783-9315-47DE-B1E4-5BED25F2D5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28981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0E99B14-B598-549C-3547-98C74698B8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FE35EB6C-260E-49B3-02CD-EE41992E5F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F07061D-1B2C-21A3-68C9-94D960006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E10A-7B40-430A-83B8-ADE1586ECA43}" type="datetimeFigureOut">
              <a:rPr lang="es-ES" smtClean="0"/>
              <a:t>22/09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A06376A1-5AE1-C7B1-82FA-3C68556F1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30C7533-DD86-917B-1740-9BD82A48B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4E783-9315-47DE-B1E4-5BED25F2D5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9341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DF2F2B7-E080-D137-DDD1-4988E8405E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AEFC9B28-BC19-0667-08FA-8B91AF1B2D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336BC98E-A104-C55A-CB7C-E950A06FA7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E10A-7B40-430A-83B8-ADE1586ECA43}" type="datetimeFigureOut">
              <a:rPr lang="es-ES" smtClean="0"/>
              <a:t>22/09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30970F6-B03E-0B1B-8E12-B59A71F23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9A45174-F8BA-97CA-B9C5-8DF23F9344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4E783-9315-47DE-B1E4-5BED25F2D5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06230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3954201-8693-C803-4AA1-9BC54BDD6F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5B1B33C-1EE1-97B0-F087-91C63EA290A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FD8367D-9399-F633-2F08-2E12B4BDD8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2BB836F-09BE-D3F6-DF2F-6D83F2CF70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E10A-7B40-430A-83B8-ADE1586ECA43}" type="datetimeFigureOut">
              <a:rPr lang="es-ES" smtClean="0"/>
              <a:t>22/09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EA9B6FC-3CE8-688A-1415-465FE233F1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EA8E52D-37BF-4C0C-E0BE-6A5570C6E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4E783-9315-47DE-B1E4-5BED25F2D5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81925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1E2B457-4889-6920-C10A-8F87D5958E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E4A91A9D-0C73-BF61-DD0D-86A02425BA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D0E0D024-24A7-2B6C-89A7-674D3CAB2F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9F93B2C6-1236-05CF-0B6A-FA14231896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315FF08F-0780-D5D9-B7DA-CD3E3753FF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84D1DB49-F476-810F-9107-A5A44F418A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E10A-7B40-430A-83B8-ADE1586ECA43}" type="datetimeFigureOut">
              <a:rPr lang="es-ES" smtClean="0"/>
              <a:t>22/09/2025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35C46640-4F2E-F86D-F9BA-BD78B8E9C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3CADE92-B9C3-BFD5-70AA-622ADFC25A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4E783-9315-47DE-B1E4-5BED25F2D5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9538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9CA09E9-FFD5-9260-5527-E4C390CAAE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DBA14B7C-11D6-C570-21E5-7D005EB19B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E10A-7B40-430A-83B8-ADE1586ECA43}" type="datetimeFigureOut">
              <a:rPr lang="es-ES" smtClean="0"/>
              <a:t>22/09/2025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7B169EAF-6467-B9A0-CCCA-B3AEBB3EDD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9948B2F6-1146-B73D-1822-4AA87CDE64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4E783-9315-47DE-B1E4-5BED25F2D5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12238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08A1FD3A-42E1-5577-2509-6D52F9017E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E10A-7B40-430A-83B8-ADE1586ECA43}" type="datetimeFigureOut">
              <a:rPr lang="es-ES" smtClean="0"/>
              <a:t>22/09/2025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66732682-93F3-4D4C-55A4-8D5134F35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F7722AA6-AE46-6D47-D4C7-93201FC38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4E783-9315-47DE-B1E4-5BED25F2D5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2378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B1E328B-57BE-C7EF-E348-21D494FA8E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65E81A2-0D79-97A0-DAD8-166E659755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F880253D-078F-C52E-FB87-38F210B499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EA861B9-62C5-BCF6-E9F4-E1B1E65E6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E10A-7B40-430A-83B8-ADE1586ECA43}" type="datetimeFigureOut">
              <a:rPr lang="es-ES" smtClean="0"/>
              <a:t>22/09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C85EBB4-2540-1F3E-81AD-A64227EDD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630A261-41C3-D2FF-93E2-BEA3D8BB1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4E783-9315-47DE-B1E4-5BED25F2D5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746586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94CAC85-F594-A38A-73AB-88D82E231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85C01CFC-E413-DC77-C22C-D2F1C1D129C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36E34FB-3EFC-0107-1CFE-16F0BBC95F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0FDEA00-5427-4282-03AC-516E7AD79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64E10A-7B40-430A-83B8-ADE1586ECA43}" type="datetimeFigureOut">
              <a:rPr lang="es-ES" smtClean="0"/>
              <a:t>22/09/2025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A487F65-9B99-457F-04CC-AA667CB9E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732DC549-B4CA-E828-655A-BD76E8056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84E783-9315-47DE-B1E4-5BED25F2D5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046632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B2690D0D-7CE6-4D72-6292-AABB2E8505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DAFE359-6F2E-91CB-77F1-EC5E178D16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084242D-6BCD-972B-BE2E-5860DE763D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864E10A-7B40-430A-83B8-ADE1586ECA43}" type="datetimeFigureOut">
              <a:rPr lang="es-ES" smtClean="0"/>
              <a:t>22/09/2025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1D5F1AD-3545-B150-4707-E4A1D199A8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A240507-FDBD-21C7-78D6-DE4868C818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A84E783-9315-47DE-B1E4-5BED25F2D51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10084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4.wdp"/><Relationship Id="rId7" Type="http://schemas.microsoft.com/office/2007/relationships/hdphoto" Target="../media/hdphoto6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microsoft.com/office/2007/relationships/hdphoto" Target="../media/hdphoto5.wdp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7" Type="http://schemas.microsoft.com/office/2007/relationships/hdphoto" Target="../media/hdphoto9.wdp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png"/><Relationship Id="rId5" Type="http://schemas.microsoft.com/office/2007/relationships/hdphoto" Target="../media/hdphoto8.wdp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7" Type="http://schemas.microsoft.com/office/2007/relationships/hdphoto" Target="../media/hdphoto12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microsoft.com/office/2007/relationships/hdphoto" Target="../media/hdphoto11.wdp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3.wdp"/><Relationship Id="rId7" Type="http://schemas.microsoft.com/office/2007/relationships/hdphoto" Target="../media/hdphoto15.wdp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5" Type="http://schemas.microsoft.com/office/2007/relationships/hdphoto" Target="../media/hdphoto14.wdp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6.wdp"/><Relationship Id="rId7" Type="http://schemas.microsoft.com/office/2007/relationships/hdphoto" Target="../media/hdphoto18.wdp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8.png"/><Relationship Id="rId5" Type="http://schemas.microsoft.com/office/2007/relationships/hdphoto" Target="../media/hdphoto17.wdp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915617AB-95FE-B154-1D45-8C78C21914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15793" y="589125"/>
            <a:ext cx="3505200" cy="5715000"/>
          </a:xfrm>
          <a:prstGeom prst="rect">
            <a:avLst/>
          </a:prstGeom>
        </p:spPr>
      </p:pic>
      <p:pic>
        <p:nvPicPr>
          <p:cNvPr id="7" name="Imagen 6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1885FD2F-24FD-B7EB-687C-1E5F3D7B1BA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43184" y="3765900"/>
            <a:ext cx="5066048" cy="2816673"/>
          </a:xfrm>
          <a:prstGeom prst="rect">
            <a:avLst/>
          </a:prstGeom>
        </p:spPr>
      </p:pic>
      <p:pic>
        <p:nvPicPr>
          <p:cNvPr id="9" name="Imagen 8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AF1C62A5-7C30-86F4-1424-2078FE07866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8363" y="600222"/>
            <a:ext cx="3626393" cy="2937078"/>
          </a:xfrm>
          <a:prstGeom prst="rect">
            <a:avLst/>
          </a:prstGeom>
        </p:spPr>
      </p:pic>
      <p:sp>
        <p:nvSpPr>
          <p:cNvPr id="10" name="CuadroTexto 9">
            <a:extLst>
              <a:ext uri="{FF2B5EF4-FFF2-40B4-BE49-F238E27FC236}">
                <a16:creationId xmlns:a16="http://schemas.microsoft.com/office/drawing/2014/main" id="{B8409EA6-2385-C455-1333-1D5FAAB3396B}"/>
              </a:ext>
            </a:extLst>
          </p:cNvPr>
          <p:cNvSpPr txBox="1"/>
          <p:nvPr/>
        </p:nvSpPr>
        <p:spPr>
          <a:xfrm>
            <a:off x="1395265" y="176740"/>
            <a:ext cx="2386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Infection</a:t>
            </a:r>
            <a:r>
              <a:rPr lang="es-ES" dirty="0"/>
              <a:t> por </a:t>
            </a:r>
            <a:r>
              <a:rPr lang="es-ES" dirty="0" err="1"/>
              <a:t>outcome</a:t>
            </a:r>
            <a:endParaRPr lang="es-ES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8AE8B039-71F6-266B-037C-0FF9A5BF2607}"/>
              </a:ext>
            </a:extLst>
          </p:cNvPr>
          <p:cNvSpPr txBox="1"/>
          <p:nvPr/>
        </p:nvSpPr>
        <p:spPr>
          <a:xfrm>
            <a:off x="4459692" y="-21458"/>
            <a:ext cx="15877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Non </a:t>
            </a:r>
            <a:r>
              <a:rPr lang="es-ES" dirty="0" err="1"/>
              <a:t>infection</a:t>
            </a:r>
            <a:endParaRPr lang="es-ES" dirty="0"/>
          </a:p>
          <a:p>
            <a:r>
              <a:rPr lang="es-ES" dirty="0"/>
              <a:t>por </a:t>
            </a:r>
            <a:r>
              <a:rPr lang="es-ES" dirty="0" err="1"/>
              <a:t>ouotcome</a:t>
            </a:r>
            <a:endParaRPr lang="es-ES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3701B687-1108-97F5-4FA5-6915974C5619}"/>
              </a:ext>
            </a:extLst>
          </p:cNvPr>
          <p:cNvSpPr txBox="1"/>
          <p:nvPr/>
        </p:nvSpPr>
        <p:spPr>
          <a:xfrm>
            <a:off x="107529" y="117042"/>
            <a:ext cx="8242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MC1</a:t>
            </a:r>
          </a:p>
        </p:txBody>
      </p: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847BA004-BBEB-D3DB-59B4-B7E58BB322CA}"/>
              </a:ext>
            </a:extLst>
          </p:cNvPr>
          <p:cNvCxnSpPr/>
          <p:nvPr/>
        </p:nvCxnSpPr>
        <p:spPr>
          <a:xfrm>
            <a:off x="4057650" y="589125"/>
            <a:ext cx="0" cy="2839875"/>
          </a:xfrm>
          <a:prstGeom prst="line">
            <a:avLst/>
          </a:prstGeom>
          <a:ln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543370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149F3CF-7C71-7593-FFC4-8FD07EC63DB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uadroTexto 9">
            <a:extLst>
              <a:ext uri="{FF2B5EF4-FFF2-40B4-BE49-F238E27FC236}">
                <a16:creationId xmlns:a16="http://schemas.microsoft.com/office/drawing/2014/main" id="{190A3C1D-0A8F-883A-FD42-49F752B2FA17}"/>
              </a:ext>
            </a:extLst>
          </p:cNvPr>
          <p:cNvSpPr txBox="1"/>
          <p:nvPr/>
        </p:nvSpPr>
        <p:spPr>
          <a:xfrm>
            <a:off x="107529" y="1301671"/>
            <a:ext cx="2386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Infection</a:t>
            </a:r>
            <a:r>
              <a:rPr lang="es-ES" dirty="0"/>
              <a:t> por </a:t>
            </a:r>
            <a:r>
              <a:rPr lang="es-ES" dirty="0" err="1"/>
              <a:t>outcome</a:t>
            </a:r>
            <a:endParaRPr lang="es-ES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50D376C3-0EA3-6B63-A19B-73E014794E9A}"/>
              </a:ext>
            </a:extLst>
          </p:cNvPr>
          <p:cNvSpPr txBox="1"/>
          <p:nvPr/>
        </p:nvSpPr>
        <p:spPr>
          <a:xfrm>
            <a:off x="2862858" y="1024672"/>
            <a:ext cx="15877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Non </a:t>
            </a:r>
            <a:r>
              <a:rPr lang="es-ES" dirty="0" err="1"/>
              <a:t>infection</a:t>
            </a:r>
            <a:endParaRPr lang="es-ES" dirty="0"/>
          </a:p>
          <a:p>
            <a:r>
              <a:rPr lang="es-ES" dirty="0"/>
              <a:t>por </a:t>
            </a:r>
            <a:r>
              <a:rPr lang="es-ES" dirty="0" err="1"/>
              <a:t>ouotcome</a:t>
            </a:r>
            <a:endParaRPr lang="es-ES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04803AF7-5266-BF70-9F5D-26253530FFE3}"/>
              </a:ext>
            </a:extLst>
          </p:cNvPr>
          <p:cNvSpPr txBox="1"/>
          <p:nvPr/>
        </p:nvSpPr>
        <p:spPr>
          <a:xfrm>
            <a:off x="107529" y="117042"/>
            <a:ext cx="8279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COHA</a:t>
            </a:r>
          </a:p>
        </p:txBody>
      </p:sp>
      <p:pic>
        <p:nvPicPr>
          <p:cNvPr id="3" name="Imagen 2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1AB2F0E4-8893-76D2-790C-14019637D1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48751" y="1809906"/>
            <a:ext cx="2463993" cy="3890515"/>
          </a:xfrm>
          <a:prstGeom prst="rect">
            <a:avLst/>
          </a:prstGeom>
        </p:spPr>
      </p:pic>
      <p:pic>
        <p:nvPicPr>
          <p:cNvPr id="6" name="Imagen 5" descr="Fondo blanco con letras negras&#10;&#10;El contenido generado por IA puede ser incorrecto.">
            <a:extLst>
              <a:ext uri="{FF2B5EF4-FFF2-40B4-BE49-F238E27FC236}">
                <a16:creationId xmlns:a16="http://schemas.microsoft.com/office/drawing/2014/main" id="{3DAAA978-1627-C3A1-D6EA-3ECF2B51ACB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9838" y="1809906"/>
            <a:ext cx="2626891" cy="3648460"/>
          </a:xfrm>
          <a:prstGeom prst="rect">
            <a:avLst/>
          </a:prstGeom>
        </p:spPr>
      </p:pic>
      <p:pic>
        <p:nvPicPr>
          <p:cNvPr id="13" name="Imagen 12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5BB83CFD-7033-56BB-3302-7CE3891EC3E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6327" y="1809906"/>
            <a:ext cx="2626892" cy="3726088"/>
          </a:xfrm>
          <a:prstGeom prst="rect">
            <a:avLst/>
          </a:prstGeom>
        </p:spPr>
      </p:pic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138EDEDC-326C-251E-A07A-7ABDF53D7723}"/>
              </a:ext>
            </a:extLst>
          </p:cNvPr>
          <p:cNvCxnSpPr/>
          <p:nvPr/>
        </p:nvCxnSpPr>
        <p:spPr>
          <a:xfrm>
            <a:off x="2619375" y="1532100"/>
            <a:ext cx="0" cy="2839875"/>
          </a:xfrm>
          <a:prstGeom prst="line">
            <a:avLst/>
          </a:prstGeom>
          <a:ln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518281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C856062-DADD-F1CE-7C67-7C111004EB1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uadroTexto 9">
            <a:extLst>
              <a:ext uri="{FF2B5EF4-FFF2-40B4-BE49-F238E27FC236}">
                <a16:creationId xmlns:a16="http://schemas.microsoft.com/office/drawing/2014/main" id="{97C67DBB-3C65-6BB5-70FD-7E7ED96A276C}"/>
              </a:ext>
            </a:extLst>
          </p:cNvPr>
          <p:cNvSpPr txBox="1"/>
          <p:nvPr/>
        </p:nvSpPr>
        <p:spPr>
          <a:xfrm>
            <a:off x="107529" y="1301671"/>
            <a:ext cx="2386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Infection</a:t>
            </a:r>
            <a:r>
              <a:rPr lang="es-ES" dirty="0"/>
              <a:t> por </a:t>
            </a:r>
            <a:r>
              <a:rPr lang="es-ES" dirty="0" err="1"/>
              <a:t>outcome</a:t>
            </a:r>
            <a:endParaRPr lang="es-ES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A598C7F8-2B58-10FE-BE84-BFCE8B3A89FD}"/>
              </a:ext>
            </a:extLst>
          </p:cNvPr>
          <p:cNvSpPr txBox="1"/>
          <p:nvPr/>
        </p:nvSpPr>
        <p:spPr>
          <a:xfrm>
            <a:off x="2862858" y="1024672"/>
            <a:ext cx="15877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Non </a:t>
            </a:r>
            <a:r>
              <a:rPr lang="es-ES" dirty="0" err="1"/>
              <a:t>infection</a:t>
            </a:r>
            <a:endParaRPr lang="es-ES" dirty="0"/>
          </a:p>
          <a:p>
            <a:r>
              <a:rPr lang="es-ES" dirty="0"/>
              <a:t>por </a:t>
            </a:r>
            <a:r>
              <a:rPr lang="es-ES" dirty="0" err="1"/>
              <a:t>ouotcome</a:t>
            </a:r>
            <a:endParaRPr lang="es-ES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797D1BBE-06B9-3923-0B2C-7A99CDF13D8E}"/>
              </a:ext>
            </a:extLst>
          </p:cNvPr>
          <p:cNvSpPr txBox="1"/>
          <p:nvPr/>
        </p:nvSpPr>
        <p:spPr>
          <a:xfrm>
            <a:off x="107529" y="117042"/>
            <a:ext cx="9060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H2B1C</a:t>
            </a:r>
          </a:p>
        </p:txBody>
      </p:sp>
      <p:pic>
        <p:nvPicPr>
          <p:cNvPr id="4" name="Imagen 3" descr="Patrón de fondo&#10;&#10;El contenido generado por IA puede ser incorrecto.">
            <a:extLst>
              <a:ext uri="{FF2B5EF4-FFF2-40B4-BE49-F238E27FC236}">
                <a16:creationId xmlns:a16="http://schemas.microsoft.com/office/drawing/2014/main" id="{9D2667DC-1A8C-584C-0EFD-B90352B0BC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785" y="1671003"/>
            <a:ext cx="3078038" cy="4711283"/>
          </a:xfrm>
          <a:prstGeom prst="rect">
            <a:avLst/>
          </a:prstGeom>
        </p:spPr>
      </p:pic>
      <p:pic>
        <p:nvPicPr>
          <p:cNvPr id="7" name="Imagen 6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77B6FB3A-1B83-17ED-9E5F-C51DFF61E6D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63432" y="1961515"/>
            <a:ext cx="3180969" cy="3943350"/>
          </a:xfrm>
          <a:prstGeom prst="rect">
            <a:avLst/>
          </a:prstGeom>
        </p:spPr>
      </p:pic>
      <p:pic>
        <p:nvPicPr>
          <p:cNvPr id="9" name="Imagen 8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35FC160F-995F-490E-7630-897B93794CB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9655" y="1671003"/>
            <a:ext cx="2774950" cy="4524375"/>
          </a:xfrm>
          <a:prstGeom prst="rect">
            <a:avLst/>
          </a:prstGeom>
        </p:spPr>
      </p:pic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F3FC298A-2001-6A2A-1A9C-A25C7A4B2F9C}"/>
              </a:ext>
            </a:extLst>
          </p:cNvPr>
          <p:cNvCxnSpPr/>
          <p:nvPr/>
        </p:nvCxnSpPr>
        <p:spPr>
          <a:xfrm>
            <a:off x="2619375" y="1532100"/>
            <a:ext cx="0" cy="2839875"/>
          </a:xfrm>
          <a:prstGeom prst="line">
            <a:avLst/>
          </a:prstGeom>
          <a:ln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897310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13F101B-5421-5545-EEE2-BDC6549B9BB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uadroTexto 9">
            <a:extLst>
              <a:ext uri="{FF2B5EF4-FFF2-40B4-BE49-F238E27FC236}">
                <a16:creationId xmlns:a16="http://schemas.microsoft.com/office/drawing/2014/main" id="{E2498130-BA25-56AC-997F-1FC19B893612}"/>
              </a:ext>
            </a:extLst>
          </p:cNvPr>
          <p:cNvSpPr txBox="1"/>
          <p:nvPr/>
        </p:nvSpPr>
        <p:spPr>
          <a:xfrm>
            <a:off x="107529" y="1301671"/>
            <a:ext cx="2386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Infection</a:t>
            </a:r>
            <a:r>
              <a:rPr lang="es-ES" dirty="0"/>
              <a:t> por </a:t>
            </a:r>
            <a:r>
              <a:rPr lang="es-ES" dirty="0" err="1"/>
              <a:t>outcome</a:t>
            </a:r>
            <a:endParaRPr lang="es-ES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39BB4E68-2F88-8FEB-087F-5122535A90B3}"/>
              </a:ext>
            </a:extLst>
          </p:cNvPr>
          <p:cNvSpPr txBox="1"/>
          <p:nvPr/>
        </p:nvSpPr>
        <p:spPr>
          <a:xfrm>
            <a:off x="2862858" y="1024672"/>
            <a:ext cx="15877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Non </a:t>
            </a:r>
            <a:r>
              <a:rPr lang="es-ES" dirty="0" err="1"/>
              <a:t>infection</a:t>
            </a:r>
            <a:endParaRPr lang="es-ES" dirty="0"/>
          </a:p>
          <a:p>
            <a:r>
              <a:rPr lang="es-ES" dirty="0"/>
              <a:t>por </a:t>
            </a:r>
            <a:r>
              <a:rPr lang="es-ES" dirty="0" err="1"/>
              <a:t>ouotcome</a:t>
            </a:r>
            <a:endParaRPr lang="es-ES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754824A1-6BA2-0C57-CFE2-32D086CC8F7B}"/>
              </a:ext>
            </a:extLst>
          </p:cNvPr>
          <p:cNvSpPr txBox="1"/>
          <p:nvPr/>
        </p:nvSpPr>
        <p:spPr>
          <a:xfrm>
            <a:off x="107529" y="117042"/>
            <a:ext cx="18020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MTEX / SKIV2L2</a:t>
            </a:r>
          </a:p>
        </p:txBody>
      </p:sp>
      <p:pic>
        <p:nvPicPr>
          <p:cNvPr id="3" name="Imagen 2" descr="Imagen que contiene Interfaz de usuario gráfica&#10;&#10;El contenido generado por IA puede ser incorrecto.">
            <a:extLst>
              <a:ext uri="{FF2B5EF4-FFF2-40B4-BE49-F238E27FC236}">
                <a16:creationId xmlns:a16="http://schemas.microsoft.com/office/drawing/2014/main" id="{115299E6-F93E-3A88-27EC-FA8B4EF167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6563" y="1868010"/>
            <a:ext cx="2636365" cy="4418489"/>
          </a:xfrm>
          <a:prstGeom prst="rect">
            <a:avLst/>
          </a:prstGeom>
        </p:spPr>
      </p:pic>
      <p:pic>
        <p:nvPicPr>
          <p:cNvPr id="6" name="Imagen 5" descr="Fondo blanco con letras negras&#10;&#10;El contenido generado por IA puede ser incorrecto.">
            <a:extLst>
              <a:ext uri="{FF2B5EF4-FFF2-40B4-BE49-F238E27FC236}">
                <a16:creationId xmlns:a16="http://schemas.microsoft.com/office/drawing/2014/main" id="{41818EA2-E22A-17C2-B4BD-5B71256763F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0380" y="1990725"/>
            <a:ext cx="4453931" cy="3403396"/>
          </a:xfrm>
          <a:prstGeom prst="rect">
            <a:avLst/>
          </a:prstGeom>
        </p:spPr>
      </p:pic>
      <p:pic>
        <p:nvPicPr>
          <p:cNvPr id="13" name="Imagen 12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C51400CE-5A65-FAF7-C0DC-21BA12FB63D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50600" y="1198766"/>
            <a:ext cx="3010668" cy="5473942"/>
          </a:xfrm>
          <a:prstGeom prst="rect">
            <a:avLst/>
          </a:prstGeom>
        </p:spPr>
      </p:pic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4224F9CD-80E2-FF68-8DA5-444AF06E205D}"/>
              </a:ext>
            </a:extLst>
          </p:cNvPr>
          <p:cNvCxnSpPr/>
          <p:nvPr/>
        </p:nvCxnSpPr>
        <p:spPr>
          <a:xfrm>
            <a:off x="2619375" y="1532100"/>
            <a:ext cx="0" cy="2839875"/>
          </a:xfrm>
          <a:prstGeom prst="line">
            <a:avLst/>
          </a:prstGeom>
          <a:ln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474798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C4FDED5-3676-9390-0D8B-413B8489BDB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uadroTexto 9">
            <a:extLst>
              <a:ext uri="{FF2B5EF4-FFF2-40B4-BE49-F238E27FC236}">
                <a16:creationId xmlns:a16="http://schemas.microsoft.com/office/drawing/2014/main" id="{216CCBB8-986E-7E93-39D6-4BFC9A8EB6BD}"/>
              </a:ext>
            </a:extLst>
          </p:cNvPr>
          <p:cNvSpPr txBox="1"/>
          <p:nvPr/>
        </p:nvSpPr>
        <p:spPr>
          <a:xfrm>
            <a:off x="107529" y="1301671"/>
            <a:ext cx="2386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Infection</a:t>
            </a:r>
            <a:r>
              <a:rPr lang="es-ES" dirty="0"/>
              <a:t> por </a:t>
            </a:r>
            <a:r>
              <a:rPr lang="es-ES" dirty="0" err="1"/>
              <a:t>outcome</a:t>
            </a:r>
            <a:endParaRPr lang="es-ES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2E2737D7-E8AA-80C4-D732-C89B402F8DC0}"/>
              </a:ext>
            </a:extLst>
          </p:cNvPr>
          <p:cNvSpPr txBox="1"/>
          <p:nvPr/>
        </p:nvSpPr>
        <p:spPr>
          <a:xfrm>
            <a:off x="2862858" y="1024672"/>
            <a:ext cx="15877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Non </a:t>
            </a:r>
            <a:r>
              <a:rPr lang="es-ES" dirty="0" err="1"/>
              <a:t>infection</a:t>
            </a:r>
            <a:endParaRPr lang="es-ES" dirty="0"/>
          </a:p>
          <a:p>
            <a:r>
              <a:rPr lang="es-ES" dirty="0"/>
              <a:t>por </a:t>
            </a:r>
            <a:r>
              <a:rPr lang="es-ES" dirty="0" err="1"/>
              <a:t>ouotcome</a:t>
            </a:r>
            <a:endParaRPr lang="es-ES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6A7B7DFC-366C-7AB8-E940-996E98A0BD08}"/>
              </a:ext>
            </a:extLst>
          </p:cNvPr>
          <p:cNvSpPr txBox="1"/>
          <p:nvPr/>
        </p:nvSpPr>
        <p:spPr>
          <a:xfrm>
            <a:off x="107529" y="117042"/>
            <a:ext cx="893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PCSK9</a:t>
            </a:r>
          </a:p>
        </p:txBody>
      </p:sp>
      <p:pic>
        <p:nvPicPr>
          <p:cNvPr id="4" name="Imagen 3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6ED84928-F9B7-B483-0ABC-B23378DBA8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4400" y="1814510"/>
            <a:ext cx="2825750" cy="4238625"/>
          </a:xfrm>
          <a:prstGeom prst="rect">
            <a:avLst/>
          </a:prstGeom>
        </p:spPr>
      </p:pic>
      <p:pic>
        <p:nvPicPr>
          <p:cNvPr id="9" name="Imagen 8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B0DC497C-807A-D4B4-7F3E-01DA497A940A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625" y="2201150"/>
            <a:ext cx="4700703" cy="4085350"/>
          </a:xfrm>
          <a:prstGeom prst="rect">
            <a:avLst/>
          </a:prstGeom>
        </p:spPr>
      </p:pic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B4C43BEF-9B9B-5A24-C8CD-539272A7BE2C}"/>
              </a:ext>
            </a:extLst>
          </p:cNvPr>
          <p:cNvCxnSpPr/>
          <p:nvPr/>
        </p:nvCxnSpPr>
        <p:spPr>
          <a:xfrm>
            <a:off x="2619375" y="1532100"/>
            <a:ext cx="0" cy="2839875"/>
          </a:xfrm>
          <a:prstGeom prst="line">
            <a:avLst/>
          </a:prstGeom>
          <a:ln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" name="Imagen 2" descr="Fondo blanco con letras negras&#10;&#10;El contenido generado por IA puede ser incorrecto.">
            <a:extLst>
              <a:ext uri="{FF2B5EF4-FFF2-40B4-BE49-F238E27FC236}">
                <a16:creationId xmlns:a16="http://schemas.microsoft.com/office/drawing/2014/main" id="{17915F4D-BE4F-AC46-F84A-1E2F097BF17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85222" y="2654247"/>
            <a:ext cx="3856674" cy="2559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16392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A0D47D-E0B7-F648-E96A-A4C0BB5BC3B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CuadroTexto 9">
            <a:extLst>
              <a:ext uri="{FF2B5EF4-FFF2-40B4-BE49-F238E27FC236}">
                <a16:creationId xmlns:a16="http://schemas.microsoft.com/office/drawing/2014/main" id="{6BF60E06-E024-9E04-6979-2C1E9E364D93}"/>
              </a:ext>
            </a:extLst>
          </p:cNvPr>
          <p:cNvSpPr txBox="1"/>
          <p:nvPr/>
        </p:nvSpPr>
        <p:spPr>
          <a:xfrm>
            <a:off x="107529" y="1301671"/>
            <a:ext cx="2386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Infection</a:t>
            </a:r>
            <a:r>
              <a:rPr lang="es-ES" dirty="0"/>
              <a:t> por </a:t>
            </a:r>
            <a:r>
              <a:rPr lang="es-ES" dirty="0" err="1"/>
              <a:t>outcome</a:t>
            </a:r>
            <a:endParaRPr lang="es-ES" dirty="0"/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1BACDEA8-323E-44A8-DB40-CDF558B3AE8D}"/>
              </a:ext>
            </a:extLst>
          </p:cNvPr>
          <p:cNvSpPr txBox="1"/>
          <p:nvPr/>
        </p:nvSpPr>
        <p:spPr>
          <a:xfrm>
            <a:off x="2862858" y="1024672"/>
            <a:ext cx="15877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/>
              <a:t>Non </a:t>
            </a:r>
            <a:r>
              <a:rPr lang="es-ES" dirty="0" err="1"/>
              <a:t>infection</a:t>
            </a:r>
            <a:endParaRPr lang="es-ES" dirty="0"/>
          </a:p>
          <a:p>
            <a:r>
              <a:rPr lang="es-ES" dirty="0"/>
              <a:t>por </a:t>
            </a:r>
            <a:r>
              <a:rPr lang="es-ES" dirty="0" err="1"/>
              <a:t>ouotcome</a:t>
            </a:r>
            <a:endParaRPr lang="es-ES" dirty="0"/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8FCD2DAE-2D94-0013-F148-F97E357BB68C}"/>
              </a:ext>
            </a:extLst>
          </p:cNvPr>
          <p:cNvSpPr txBox="1"/>
          <p:nvPr/>
        </p:nvSpPr>
        <p:spPr>
          <a:xfrm>
            <a:off x="107529" y="117042"/>
            <a:ext cx="9076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PSME1</a:t>
            </a:r>
          </a:p>
        </p:txBody>
      </p:sp>
      <p:pic>
        <p:nvPicPr>
          <p:cNvPr id="7" name="Imagen 6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56FFAE04-3213-5186-0489-0C1FB05D25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757974" y="1661751"/>
            <a:ext cx="2791114" cy="3894578"/>
          </a:xfrm>
          <a:prstGeom prst="rect">
            <a:avLst/>
          </a:prstGeom>
        </p:spPr>
      </p:pic>
      <p:pic>
        <p:nvPicPr>
          <p:cNvPr id="13" name="Imagen 12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8E77620B-66D6-7680-9A00-FA776066780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5251" y="2009062"/>
            <a:ext cx="4396536" cy="3623852"/>
          </a:xfrm>
          <a:prstGeom prst="rect">
            <a:avLst/>
          </a:prstGeom>
        </p:spPr>
      </p:pic>
      <p:pic>
        <p:nvPicPr>
          <p:cNvPr id="16" name="Imagen 15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486B8AD6-A3DC-9EAA-DC81-F116F5ECBF8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00117" y="1858522"/>
            <a:ext cx="2998103" cy="4183399"/>
          </a:xfrm>
          <a:prstGeom prst="rect">
            <a:avLst/>
          </a:prstGeom>
        </p:spPr>
      </p:pic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87078632-7DE5-FDB5-2FAD-63A221619B61}"/>
              </a:ext>
            </a:extLst>
          </p:cNvPr>
          <p:cNvCxnSpPr/>
          <p:nvPr/>
        </p:nvCxnSpPr>
        <p:spPr>
          <a:xfrm>
            <a:off x="2619375" y="1532100"/>
            <a:ext cx="0" cy="2839875"/>
          </a:xfrm>
          <a:prstGeom prst="line">
            <a:avLst/>
          </a:prstGeom>
          <a:ln>
            <a:prstDash val="dash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276803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50</Words>
  <Application>Microsoft Office PowerPoint</Application>
  <PresentationFormat>Panorámica</PresentationFormat>
  <Paragraphs>24</Paragraphs>
  <Slides>6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0" baseType="lpstr">
      <vt:lpstr>Aptos</vt:lpstr>
      <vt:lpstr>Aptos Display</vt:lpstr>
      <vt:lpstr>Arial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eurocienciasycerebrovascular@gmail.com</dc:creator>
  <cp:lastModifiedBy>neurocienciasycerebrovascular@gmail.com</cp:lastModifiedBy>
  <cp:revision>1</cp:revision>
  <dcterms:created xsi:type="dcterms:W3CDTF">2025-09-22T08:17:56Z</dcterms:created>
  <dcterms:modified xsi:type="dcterms:W3CDTF">2025-09-22T08:32:02Z</dcterms:modified>
</cp:coreProperties>
</file>